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A9E652-94D2-4194-92EA-E7D9214152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F13DB-BFE3-4929-AD79-213EAC3269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D49409-66A1-4F3F-A538-C5D7AF6CF5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EEA7C6-F46C-43A0-96FA-C5B14DFFCC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F2DC7-44D1-4A58-99CB-E48CE9F62D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9249F9-B724-42C7-B8E8-4B38AFCE1E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453300-F488-4047-B0D4-DA15F1E04D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0F77C-9E89-498F-89B4-D2E2ABFB43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420FB0-5848-44AD-83ED-BB6DE83190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DC636-5B05-4EFD-B266-DF74B8AD0A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20D4A-A19A-49CE-9424-CFC1B69EBC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F1CC24-7592-4388-8E02-5966AE0884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FE1C73-1953-48D0-B67D-46B5B1398C3A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09480" y="8380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609480" y="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609480" y="11430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609480" y="1828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609480" y="24382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04920" y="3049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228600" y="6858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2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228600" y="9907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6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228600" y="16765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5.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228600" y="22860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5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228600" y="28195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9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838080" y="349200"/>
            <a:ext cx="838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3020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838080" y="716040"/>
            <a:ext cx="1828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TG01GT, ASCA01A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838080" y="1022400"/>
            <a:ext cx="2438640" cy="70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TA02GT, AJTA03AT, AJAC03TA,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TA01TT, AJCC02TG, ASTA02AT,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AG02TC, ASAA01TC, AJTA02TT,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AA02CA, AJCG02T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838080" y="1706400"/>
            <a:ext cx="914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AG01G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838080" y="2300400"/>
            <a:ext cx="1828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TG01AA, AJTG01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838080" y="2849400"/>
            <a:ext cx="1067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CA02A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4724280" y="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4419720" y="3049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4267080" y="281952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28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4724280" y="7621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4724280" y="8841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4724280" y="10047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4726080" y="14050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4724280" y="12952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4724280" y="16002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4724280" y="17082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724280" y="1828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4724280" y="20574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4724280" y="27432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4724280" y="24066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4724280" y="25909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4419720" y="4572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4724280" y="577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4343400" y="6094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9.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4343400" y="7621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3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4343400" y="9144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6.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4343400" y="11430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4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4343400" y="12952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8.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4343400" y="14479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0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4343400" y="16002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4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4343400" y="17524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8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4343400" y="19350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0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4343400" y="22557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82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4343400" y="24382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95.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4267080" y="25909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5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4952880" y="351000"/>
            <a:ext cx="1067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AT02AG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4952880" y="487440"/>
            <a:ext cx="12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TA05AT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4952880" y="625320"/>
            <a:ext cx="16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CC01TT, AJCC02TT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4952880" y="777960"/>
            <a:ext cx="114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AT03TC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4952880" y="900000"/>
            <a:ext cx="160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CC05TT, ASAA03T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4952880" y="1174680"/>
            <a:ext cx="914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AT02AG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4967280" y="1311120"/>
            <a:ext cx="83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302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4952880" y="1494000"/>
            <a:ext cx="914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CG04TA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4952880" y="1601640"/>
            <a:ext cx="2743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AA02GA, AJAA01GC, ASGT05AT, AJGT06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4952880" y="1739880"/>
            <a:ext cx="137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CT04TT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4952880" y="1920960"/>
            <a:ext cx="335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AC03AT, ASAA04AC, ASTA05TA, AJAA04AC, AJAT07AT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4951440" y="2087640"/>
            <a:ext cx="3809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CC01AA, ASAC01AG, AJAT01AT, ASTA01AC, AJTA01AC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4724280" y="22096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4343400" y="20574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4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4951440" y="2300400"/>
            <a:ext cx="4192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CA01TC, ASCA01AT, ASAC02GA, AJCC01GA, AJAA03TA, ASCA02GA, AJAG01T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4952880" y="2468520"/>
            <a:ext cx="838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29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4952880" y="2622600"/>
            <a:ext cx="762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NA pol σ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4724280" y="28494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4267080" y="2695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17.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4938840" y="2697120"/>
            <a:ext cx="1066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PL-16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4937040" y="2806560"/>
            <a:ext cx="914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30035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08" name=""/>
          <p:cNvGrpSpPr/>
          <p:nvPr/>
        </p:nvGrpSpPr>
        <p:grpSpPr>
          <a:xfrm>
            <a:off x="609480" y="3657600"/>
            <a:ext cx="228600" cy="2516040"/>
            <a:chOff x="609480" y="3657600"/>
            <a:chExt cx="228600" cy="2516040"/>
          </a:xfrm>
        </p:grpSpPr>
        <p:grpSp>
          <p:nvGrpSpPr>
            <p:cNvPr id="109" name=""/>
            <p:cNvGrpSpPr/>
            <p:nvPr/>
          </p:nvGrpSpPr>
          <p:grpSpPr>
            <a:xfrm>
              <a:off x="609480" y="3657600"/>
              <a:ext cx="228600" cy="2516040"/>
              <a:chOff x="609480" y="3657600"/>
              <a:chExt cx="228600" cy="2516040"/>
            </a:xfrm>
          </p:grpSpPr>
          <p:sp>
            <p:nvSpPr>
              <p:cNvPr id="110" name=""/>
              <p:cNvSpPr/>
              <p:nvPr/>
            </p:nvSpPr>
            <p:spPr>
              <a:xfrm>
                <a:off x="685800" y="3659040"/>
                <a:ext cx="76320" cy="2514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609480" y="365760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12" name=""/>
            <p:cNvSpPr/>
            <p:nvPr/>
          </p:nvSpPr>
          <p:spPr>
            <a:xfrm>
              <a:off x="609480" y="61736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13" name=""/>
          <p:cNvSpPr/>
          <p:nvPr/>
        </p:nvSpPr>
        <p:spPr>
          <a:xfrm>
            <a:off x="304920" y="35053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228600" y="601992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7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609480" y="3962520"/>
            <a:ext cx="99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609480" y="4114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609480" y="45417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609480" y="43434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609480" y="47242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609480" y="50292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609480" y="54864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228600" y="38098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1.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228600" y="39909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6.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228600" y="41911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5.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228600" y="44020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9.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228600" y="45720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7.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228600" y="48769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4.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228600" y="53341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9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609480" y="57913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228600" y="56386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2.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609480" y="327672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838080" y="3505320"/>
            <a:ext cx="16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NA pol α, P.12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1600200" y="3809880"/>
            <a:ext cx="29718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SA, AJAG02AG, ASAT01AA, ASAC02AT, ASTG01AT, ASTC01TC, AJTC01TC, ASCC01TC, AJAT02TA, AJAC01GT, AJAG02CT, ASCG01AT, AJCT01TA, AJTT05AT, AJTG02AA, AJTC02CT, AJGT01TA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838080" y="4008600"/>
            <a:ext cx="114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AG01CT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838080" y="4221000"/>
            <a:ext cx="99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GT02TG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838080" y="4403880"/>
            <a:ext cx="2895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CC01AA, AJCT02TA, AJAT03TG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839880" y="4605480"/>
            <a:ext cx="243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CC02AG, AJTA02GA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838080" y="4876920"/>
            <a:ext cx="1828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TT01CA, ASTT01CA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853920" y="5380200"/>
            <a:ext cx="16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GA02GA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824040" y="5684760"/>
            <a:ext cx="3809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CT01AA, ASTC01AA, AJTA02AC, AJGT03AT,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CA01AC, ASAG01TG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838080" y="6019920"/>
            <a:ext cx="198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CT02TT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42" name=""/>
          <p:cNvGrpSpPr/>
          <p:nvPr/>
        </p:nvGrpSpPr>
        <p:grpSpPr>
          <a:xfrm>
            <a:off x="4724280" y="457200"/>
            <a:ext cx="228600" cy="2516040"/>
            <a:chOff x="4724280" y="457200"/>
            <a:chExt cx="228600" cy="2516040"/>
          </a:xfrm>
        </p:grpSpPr>
        <p:grpSp>
          <p:nvGrpSpPr>
            <p:cNvPr id="143" name=""/>
            <p:cNvGrpSpPr/>
            <p:nvPr/>
          </p:nvGrpSpPr>
          <p:grpSpPr>
            <a:xfrm>
              <a:off x="4724280" y="457200"/>
              <a:ext cx="228600" cy="2516040"/>
              <a:chOff x="4724280" y="457200"/>
              <a:chExt cx="228600" cy="2516040"/>
            </a:xfrm>
          </p:grpSpPr>
          <p:sp>
            <p:nvSpPr>
              <p:cNvPr id="144" name=""/>
              <p:cNvSpPr/>
              <p:nvPr/>
            </p:nvSpPr>
            <p:spPr>
              <a:xfrm>
                <a:off x="4800600" y="458640"/>
                <a:ext cx="76320" cy="2514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4724280" y="45720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46" name=""/>
            <p:cNvSpPr/>
            <p:nvPr/>
          </p:nvSpPr>
          <p:spPr>
            <a:xfrm>
              <a:off x="4724280" y="29732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47" name=""/>
          <p:cNvGrpSpPr/>
          <p:nvPr/>
        </p:nvGrpSpPr>
        <p:grpSpPr>
          <a:xfrm>
            <a:off x="609480" y="457200"/>
            <a:ext cx="228600" cy="2516040"/>
            <a:chOff x="609480" y="457200"/>
            <a:chExt cx="228600" cy="2516040"/>
          </a:xfrm>
        </p:grpSpPr>
        <p:grpSp>
          <p:nvGrpSpPr>
            <p:cNvPr id="148" name=""/>
            <p:cNvGrpSpPr/>
            <p:nvPr/>
          </p:nvGrpSpPr>
          <p:grpSpPr>
            <a:xfrm>
              <a:off x="609480" y="457200"/>
              <a:ext cx="228600" cy="2516040"/>
              <a:chOff x="609480" y="457200"/>
              <a:chExt cx="228600" cy="2516040"/>
            </a:xfrm>
          </p:grpSpPr>
          <p:sp>
            <p:nvSpPr>
              <p:cNvPr id="149" name=""/>
              <p:cNvSpPr/>
              <p:nvPr/>
            </p:nvSpPr>
            <p:spPr>
              <a:xfrm>
                <a:off x="685800" y="458640"/>
                <a:ext cx="76320" cy="2514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609480" y="45720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51" name=""/>
            <p:cNvSpPr/>
            <p:nvPr/>
          </p:nvSpPr>
          <p:spPr>
            <a:xfrm>
              <a:off x="609480" y="29732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52" name=""/>
          <p:cNvSpPr/>
          <p:nvPr/>
        </p:nvSpPr>
        <p:spPr>
          <a:xfrm>
            <a:off x="5029200" y="35053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4876920" y="594360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25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5334120" y="38005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5324400" y="3905280"/>
            <a:ext cx="247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5324400" y="40719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>
            <a:off x="5326200" y="44719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5324400" y="43243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>
            <a:off x="5324400" y="45910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5324400" y="477504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5324400" y="48960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>
            <a:off x="5324400" y="51246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>
            <a:off x="5334120" y="58579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>
            <a:off x="5324400" y="5473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>
            <a:off x="5315040" y="561024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>
            <a:off x="5324400" y="41814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>
            <a:off x="4952880" y="364824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2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>
            <a:off x="4952880" y="38005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4.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>
            <a:off x="4943520" y="394344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8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4943520" y="40482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1.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>
            <a:off x="4943520" y="41911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7.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>
            <a:off x="4933800" y="44578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8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>
            <a:off x="4933800" y="46195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7.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>
            <a:off x="4933800" y="47340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2.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>
            <a:off x="4933800" y="48690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6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>
            <a:off x="4933800" y="524844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81.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"/>
          <p:cNvSpPr/>
          <p:nvPr/>
        </p:nvSpPr>
        <p:spPr>
          <a:xfrm>
            <a:off x="4924440" y="547704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99.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>
            <a:off x="4867200" y="561024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4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>
            <a:off x="5334120" y="597204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>
            <a:off x="4933800" y="50007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9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"/>
          <p:cNvSpPr/>
          <p:nvPr/>
        </p:nvSpPr>
        <p:spPr>
          <a:xfrm>
            <a:off x="5343480" y="60580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>
            <a:off x="4867200" y="572436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12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83" name=""/>
          <p:cNvGrpSpPr/>
          <p:nvPr/>
        </p:nvGrpSpPr>
        <p:grpSpPr>
          <a:xfrm>
            <a:off x="5334120" y="3657600"/>
            <a:ext cx="228600" cy="2516040"/>
            <a:chOff x="5334120" y="3657600"/>
            <a:chExt cx="228600" cy="2516040"/>
          </a:xfrm>
        </p:grpSpPr>
        <p:grpSp>
          <p:nvGrpSpPr>
            <p:cNvPr id="184" name=""/>
            <p:cNvGrpSpPr/>
            <p:nvPr/>
          </p:nvGrpSpPr>
          <p:grpSpPr>
            <a:xfrm>
              <a:off x="5334120" y="3657600"/>
              <a:ext cx="228600" cy="2516040"/>
              <a:chOff x="5334120" y="3657600"/>
              <a:chExt cx="228600" cy="2516040"/>
            </a:xfrm>
          </p:grpSpPr>
          <p:sp>
            <p:nvSpPr>
              <p:cNvPr id="185" name=""/>
              <p:cNvSpPr/>
              <p:nvPr/>
            </p:nvSpPr>
            <p:spPr>
              <a:xfrm>
                <a:off x="5410440" y="3659040"/>
                <a:ext cx="76320" cy="2514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5334120" y="365760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87" name=""/>
            <p:cNvSpPr/>
            <p:nvPr/>
          </p:nvSpPr>
          <p:spPr>
            <a:xfrm>
              <a:off x="5334120" y="61736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88" name=""/>
          <p:cNvSpPr/>
          <p:nvPr/>
        </p:nvSpPr>
        <p:spPr>
          <a:xfrm>
            <a:off x="5324400" y="57340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"/>
          <p:cNvSpPr/>
          <p:nvPr/>
        </p:nvSpPr>
        <p:spPr>
          <a:xfrm>
            <a:off x="5324400" y="53532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"/>
          <p:cNvSpPr/>
          <p:nvPr/>
        </p:nvSpPr>
        <p:spPr>
          <a:xfrm>
            <a:off x="5324400" y="50101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"/>
          <p:cNvSpPr/>
          <p:nvPr/>
        </p:nvSpPr>
        <p:spPr>
          <a:xfrm>
            <a:off x="5581800" y="3543480"/>
            <a:ext cx="1066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CT03T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"/>
          <p:cNvSpPr/>
          <p:nvPr/>
        </p:nvSpPr>
        <p:spPr>
          <a:xfrm>
            <a:off x="5581800" y="3666960"/>
            <a:ext cx="251460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AJCG01TA, AJTA02CA, AJAA04C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"/>
          <p:cNvSpPr/>
          <p:nvPr/>
        </p:nvSpPr>
        <p:spPr>
          <a:xfrm>
            <a:off x="5572080" y="3809880"/>
            <a:ext cx="800280" cy="23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AJAA02T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"/>
          <p:cNvSpPr/>
          <p:nvPr/>
        </p:nvSpPr>
        <p:spPr>
          <a:xfrm>
            <a:off x="5562720" y="3952800"/>
            <a:ext cx="22860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CC02CA, ASAT04AG, AJAA02GC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"/>
          <p:cNvSpPr/>
          <p:nvPr/>
        </p:nvSpPr>
        <p:spPr>
          <a:xfrm>
            <a:off x="5562720" y="4076640"/>
            <a:ext cx="2514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GA01CT, ASAC01GT, ASAA02G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"/>
          <p:cNvSpPr/>
          <p:nvPr/>
        </p:nvSpPr>
        <p:spPr>
          <a:xfrm>
            <a:off x="5572080" y="4210200"/>
            <a:ext cx="2514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T01GT, AJAA01GA, AJAG01AG, ASCA04T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"/>
          <p:cNvSpPr/>
          <p:nvPr/>
        </p:nvSpPr>
        <p:spPr>
          <a:xfrm>
            <a:off x="4933800" y="433404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1.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"/>
          <p:cNvSpPr/>
          <p:nvPr/>
        </p:nvSpPr>
        <p:spPr>
          <a:xfrm>
            <a:off x="5572080" y="4343400"/>
            <a:ext cx="80028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AJCA04G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"/>
          <p:cNvSpPr/>
          <p:nvPr/>
        </p:nvSpPr>
        <p:spPr>
          <a:xfrm>
            <a:off x="5572080" y="4476600"/>
            <a:ext cx="80028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ASAA01C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"/>
          <p:cNvSpPr/>
          <p:nvPr/>
        </p:nvSpPr>
        <p:spPr>
          <a:xfrm>
            <a:off x="5572080" y="4648320"/>
            <a:ext cx="800280" cy="239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ASGT06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"/>
          <p:cNvSpPr/>
          <p:nvPr/>
        </p:nvSpPr>
        <p:spPr>
          <a:xfrm>
            <a:off x="5572080" y="4781520"/>
            <a:ext cx="3571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CG03TA, AJTA01CA, ASAC02TT, ASAA05CA, ASTT03CA, AJTT06A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"/>
          <p:cNvSpPr/>
          <p:nvPr/>
        </p:nvSpPr>
        <p:spPr>
          <a:xfrm>
            <a:off x="5572080" y="4886280"/>
            <a:ext cx="16002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ASCC02AA, AJCT02TC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>
            <a:off x="5572080" y="5010120"/>
            <a:ext cx="2514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AT02AT, AJCT01CA, ASAC05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>
            <a:off x="5324400" y="5248440"/>
            <a:ext cx="2048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"/>
          <p:cNvSpPr/>
          <p:nvPr/>
        </p:nvSpPr>
        <p:spPr>
          <a:xfrm>
            <a:off x="4924440" y="5124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7.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>
            <a:off x="7334280" y="5133960"/>
            <a:ext cx="1981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TG02AT, AJGA02GT, AJAT02AC,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TG01TC, AJTA02TA, AJTG01TC,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GA03AC, ASAT02TC, AJAT02TC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"/>
          <p:cNvSpPr/>
          <p:nvPr/>
        </p:nvSpPr>
        <p:spPr>
          <a:xfrm>
            <a:off x="5562720" y="5238720"/>
            <a:ext cx="1881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A03AA, AJTT03TG, AJCA03A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"/>
          <p:cNvSpPr/>
          <p:nvPr/>
        </p:nvSpPr>
        <p:spPr>
          <a:xfrm>
            <a:off x="5553000" y="5353200"/>
            <a:ext cx="80028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DHFR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"/>
          <p:cNvSpPr/>
          <p:nvPr/>
        </p:nvSpPr>
        <p:spPr>
          <a:xfrm>
            <a:off x="4933800" y="535320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90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"/>
          <p:cNvSpPr/>
          <p:nvPr/>
        </p:nvSpPr>
        <p:spPr>
          <a:xfrm>
            <a:off x="5533920" y="5486400"/>
            <a:ext cx="129564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AJAG02CA, ASAG03C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"/>
          <p:cNvSpPr/>
          <p:nvPr/>
        </p:nvSpPr>
        <p:spPr>
          <a:xfrm>
            <a:off x="5533920" y="5629320"/>
            <a:ext cx="31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TG01GA, ASGT03TG, AJTG01AG, ASAA06AT, ASTG03C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"/>
          <p:cNvSpPr/>
          <p:nvPr/>
        </p:nvSpPr>
        <p:spPr>
          <a:xfrm>
            <a:off x="5533920" y="5753160"/>
            <a:ext cx="80028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AJAA05C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"/>
          <p:cNvSpPr/>
          <p:nvPr/>
        </p:nvSpPr>
        <p:spPr>
          <a:xfrm>
            <a:off x="4876920" y="583884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21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"/>
          <p:cNvSpPr/>
          <p:nvPr/>
        </p:nvSpPr>
        <p:spPr>
          <a:xfrm>
            <a:off x="5533920" y="5857920"/>
            <a:ext cx="12956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AS TT01AG, AJAC02T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"/>
          <p:cNvSpPr/>
          <p:nvPr/>
        </p:nvSpPr>
        <p:spPr>
          <a:xfrm>
            <a:off x="5524560" y="5952960"/>
            <a:ext cx="14479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ASAT05AT, ASAC01T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6" name=""/>
          <p:cNvSpPr/>
          <p:nvPr/>
        </p:nvSpPr>
        <p:spPr>
          <a:xfrm>
            <a:off x="5524560" y="6067440"/>
            <a:ext cx="148572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AJAA03AT, AJTC01A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"/>
          <p:cNvSpPr/>
          <p:nvPr/>
        </p:nvSpPr>
        <p:spPr>
          <a:xfrm>
            <a:off x="4867200" y="605808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32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"/>
          <p:cNvSpPr/>
          <p:nvPr/>
        </p:nvSpPr>
        <p:spPr>
          <a:xfrm>
            <a:off x="5334120" y="320040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7-21T15:24:47Z</dcterms:created>
  <dc:creator>Axel</dc:creator>
  <dc:description/>
  <dc:language>en-US</dc:language>
  <cp:lastModifiedBy>susiej</cp:lastModifiedBy>
  <dcterms:modified xsi:type="dcterms:W3CDTF">2005-02-15T12:08:05Z</dcterms:modified>
  <cp:revision>15</cp:revision>
  <dc:subject/>
  <dc:title>PowerPoint Presentation</dc:title>
</cp:coreProperties>
</file>